
<file path=[Content_Types].xml><?xml version="1.0" encoding="utf-8"?>
<Types xmlns="http://schemas.openxmlformats.org/package/2006/content-types">
  <Default Extension="gif" ContentType="image/gi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1" r:id="rId2"/>
  </p:sldIdLst>
  <p:sldSz cx="6858000" cy="9144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251F"/>
    <a:srgbClr val="00E702"/>
    <a:srgbClr val="609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22"/>
    <p:restoredTop sz="91301"/>
  </p:normalViewPr>
  <p:slideViewPr>
    <p:cSldViewPr snapToGrid="0" snapToObjects="1">
      <p:cViewPr>
        <p:scale>
          <a:sx n="100" d="100"/>
          <a:sy n="100" d="100"/>
        </p:scale>
        <p:origin x="3152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Shape 109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0" name="Shape 110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74212362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Arial"/>
      </a:defRPr>
    </a:lvl1pPr>
    <a:lvl2pPr indent="228600" latinLnBrk="0">
      <a:defRPr sz="1200">
        <a:latin typeface="+mn-lt"/>
        <a:ea typeface="+mn-ea"/>
        <a:cs typeface="+mn-cs"/>
        <a:sym typeface="Arial"/>
      </a:defRPr>
    </a:lvl2pPr>
    <a:lvl3pPr indent="457200" latinLnBrk="0">
      <a:defRPr sz="1200">
        <a:latin typeface="+mn-lt"/>
        <a:ea typeface="+mn-ea"/>
        <a:cs typeface="+mn-cs"/>
        <a:sym typeface="Arial"/>
      </a:defRPr>
    </a:lvl3pPr>
    <a:lvl4pPr indent="685800" latinLnBrk="0">
      <a:defRPr sz="1200">
        <a:latin typeface="+mn-lt"/>
        <a:ea typeface="+mn-ea"/>
        <a:cs typeface="+mn-cs"/>
        <a:sym typeface="Arial"/>
      </a:defRPr>
    </a:lvl4pPr>
    <a:lvl5pPr indent="914400" latinLnBrk="0">
      <a:defRPr sz="1200">
        <a:latin typeface="+mn-lt"/>
        <a:ea typeface="+mn-ea"/>
        <a:cs typeface="+mn-cs"/>
        <a:sym typeface="Arial"/>
      </a:defRPr>
    </a:lvl5pPr>
    <a:lvl6pPr indent="1143000" latinLnBrk="0">
      <a:defRPr sz="1200">
        <a:latin typeface="+mn-lt"/>
        <a:ea typeface="+mn-ea"/>
        <a:cs typeface="+mn-cs"/>
        <a:sym typeface="Arial"/>
      </a:defRPr>
    </a:lvl6pPr>
    <a:lvl7pPr indent="1371600" latinLnBrk="0">
      <a:defRPr sz="1200">
        <a:latin typeface="+mn-lt"/>
        <a:ea typeface="+mn-ea"/>
        <a:cs typeface="+mn-cs"/>
        <a:sym typeface="Arial"/>
      </a:defRPr>
    </a:lvl7pPr>
    <a:lvl8pPr indent="1600200" latinLnBrk="0">
      <a:defRPr sz="1200">
        <a:latin typeface="+mn-lt"/>
        <a:ea typeface="+mn-ea"/>
        <a:cs typeface="+mn-cs"/>
        <a:sym typeface="Arial"/>
      </a:defRPr>
    </a:lvl8pPr>
    <a:lvl9pPr indent="1828800" latinLnBrk="0">
      <a:defRPr sz="12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514350" y="2840568"/>
            <a:ext cx="5829300" cy="1960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028700" y="5181600"/>
            <a:ext cx="4800600" cy="23368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4972050" y="366185"/>
            <a:ext cx="1543050" cy="7802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366185"/>
            <a:ext cx="4514850" cy="7802035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541736" y="5875867"/>
            <a:ext cx="5829301" cy="1816101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541736" y="3875617"/>
            <a:ext cx="5829301" cy="2000251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342900" y="2133600"/>
            <a:ext cx="3028950" cy="6034619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42900" y="2046817"/>
            <a:ext cx="3030142" cy="853017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3483769" y="2046816"/>
            <a:ext cx="3031332" cy="853016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342901" y="364068"/>
            <a:ext cx="2256235" cy="1549401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2681286" y="364067"/>
            <a:ext cx="3833814" cy="7804152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half" idx="13"/>
          </p:nvPr>
        </p:nvSpPr>
        <p:spPr>
          <a:xfrm>
            <a:off x="342901" y="1913468"/>
            <a:ext cx="2256235" cy="625475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1344217" y="6400801"/>
            <a:ext cx="4114801" cy="755652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13"/>
          </p:nvPr>
        </p:nvSpPr>
        <p:spPr>
          <a:xfrm>
            <a:off x="1344217" y="817033"/>
            <a:ext cx="4114801" cy="5486401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344217" y="7156450"/>
            <a:ext cx="4114801" cy="1073151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342900" y="366185"/>
            <a:ext cx="6172200" cy="1524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200" cy="603461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230411" y="8580052"/>
            <a:ext cx="284691" cy="276999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  <a:latin typeface="+mn-lt"/>
                <a:ea typeface="+mn-ea"/>
                <a:cs typeface="+mn-cs"/>
                <a:sym typeface="Arial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spd="med"/>
  <p:txStyles>
    <p:titleStyle>
      <a:lvl1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titleStyle>
    <p:bodyStyle>
      <a:lvl1pPr marL="342900" marR="0" indent="-3429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783771" marR="0" indent="-326571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1219200" marR="0" indent="-3048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17373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21945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26517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31089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35661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40233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gi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B38795C0-E12D-6A48-8BF7-344D04FCC407}"/>
              </a:ext>
            </a:extLst>
          </p:cNvPr>
          <p:cNvGrpSpPr/>
          <p:nvPr/>
        </p:nvGrpSpPr>
        <p:grpSpPr>
          <a:xfrm>
            <a:off x="1050222" y="711146"/>
            <a:ext cx="5054610" cy="6688279"/>
            <a:chOff x="1050222" y="253941"/>
            <a:chExt cx="5054610" cy="668827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EB64B19-B995-3B48-A8B6-C9F86A2A6A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643" t="18571" r="13929" b="4473"/>
            <a:stretch/>
          </p:blipFill>
          <p:spPr>
            <a:xfrm>
              <a:off x="1050222" y="1928465"/>
              <a:ext cx="1206768" cy="116431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8A1CF6C-5509-8D4A-9250-796EE6C6D3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929" t="21594" r="4857" b="-107"/>
            <a:stretch/>
          </p:blipFill>
          <p:spPr>
            <a:xfrm flipH="1">
              <a:off x="2354123" y="1894035"/>
              <a:ext cx="1225417" cy="11827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7E0E5C9-692F-F34B-844F-00AC76F979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29" t="14728" r="11857" b="14487"/>
            <a:stretch/>
          </p:blipFill>
          <p:spPr>
            <a:xfrm flipH="1">
              <a:off x="3660343" y="1901458"/>
              <a:ext cx="1326565" cy="1182700"/>
            </a:xfrm>
            <a:prstGeom prst="rect">
              <a:avLst/>
            </a:prstGeom>
          </p:spPr>
        </p:pic>
        <p:sp>
          <p:nvSpPr>
            <p:cNvPr id="9" name="TextBox 33">
              <a:extLst>
                <a:ext uri="{FF2B5EF4-FFF2-40B4-BE49-F238E27FC236}">
                  <a16:creationId xmlns:a16="http://schemas.microsoft.com/office/drawing/2014/main" id="{DE4B77F1-608E-3740-BC82-4CC9F80A7AEE}"/>
                </a:ext>
              </a:extLst>
            </p:cNvPr>
            <p:cNvSpPr txBox="1"/>
            <p:nvPr/>
          </p:nvSpPr>
          <p:spPr>
            <a:xfrm>
              <a:off x="2354123" y="253942"/>
              <a:ext cx="1208605" cy="43088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sz="1100" b="1">
                  <a:latin typeface="+mn-lt"/>
                  <a:ea typeface="+mn-ea"/>
                  <a:cs typeface="+mn-cs"/>
                  <a:sym typeface="Arial"/>
                </a:defRPr>
              </a:lvl1pPr>
            </a:lstStyle>
            <a:p>
              <a:pPr algn="ctr"/>
              <a:r>
                <a:rPr dirty="0"/>
                <a:t>2 hr memory recall</a:t>
              </a:r>
            </a:p>
          </p:txBody>
        </p:sp>
        <p:sp>
          <p:nvSpPr>
            <p:cNvPr id="10" name="TextBox 34">
              <a:extLst>
                <a:ext uri="{FF2B5EF4-FFF2-40B4-BE49-F238E27FC236}">
                  <a16:creationId xmlns:a16="http://schemas.microsoft.com/office/drawing/2014/main" id="{C3D3CFDA-A045-CB45-907D-B41711F6E303}"/>
                </a:ext>
              </a:extLst>
            </p:cNvPr>
            <p:cNvSpPr txBox="1"/>
            <p:nvPr/>
          </p:nvSpPr>
          <p:spPr>
            <a:xfrm>
              <a:off x="3657899" y="253941"/>
              <a:ext cx="1193478" cy="43088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sz="1100" b="1">
                  <a:latin typeface="+mn-lt"/>
                  <a:ea typeface="+mn-ea"/>
                  <a:cs typeface="+mn-cs"/>
                  <a:sym typeface="Arial"/>
                </a:defRPr>
              </a:lvl1pPr>
            </a:lstStyle>
            <a:p>
              <a:pPr algn="ctr"/>
              <a:r>
                <a:rPr dirty="0"/>
                <a:t>24 hr memory recall</a:t>
              </a:r>
            </a:p>
          </p:txBody>
        </p:sp>
        <p:sp>
          <p:nvSpPr>
            <p:cNvPr id="11" name="TextBox 33">
              <a:extLst>
                <a:ext uri="{FF2B5EF4-FFF2-40B4-BE49-F238E27FC236}">
                  <a16:creationId xmlns:a16="http://schemas.microsoft.com/office/drawing/2014/main" id="{F89B77EA-BD12-164E-AE6A-1D4B3EA61E55}"/>
                </a:ext>
              </a:extLst>
            </p:cNvPr>
            <p:cNvSpPr txBox="1"/>
            <p:nvPr/>
          </p:nvSpPr>
          <p:spPr>
            <a:xfrm>
              <a:off x="1339265" y="325558"/>
              <a:ext cx="858651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sz="1100" b="1">
                  <a:latin typeface="+mn-lt"/>
                  <a:ea typeface="+mn-ea"/>
                  <a:cs typeface="+mn-cs"/>
                  <a:sym typeface="Arial"/>
                </a:defRPr>
              </a:lvl1pPr>
            </a:lstStyle>
            <a:p>
              <a:r>
                <a:rPr lang="en-US" dirty="0"/>
                <a:t>Training</a:t>
              </a:r>
              <a:endParaRPr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CAA0FFC-92F2-594B-A395-2FE5E255E819}"/>
                </a:ext>
              </a:extLst>
            </p:cNvPr>
            <p:cNvSpPr txBox="1"/>
            <p:nvPr/>
          </p:nvSpPr>
          <p:spPr>
            <a:xfrm>
              <a:off x="4957724" y="2292530"/>
              <a:ext cx="356827" cy="27699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>
                  <a:latin typeface="+mn-lt"/>
                </a:rPr>
                <a:t>Exo</a:t>
              </a:r>
              <a:endParaRPr kumimoji="0" lang="en-U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330FA4F9-64E6-3346-A738-7497AB970E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500" t="13924" r="13858" b="13734"/>
            <a:stretch/>
          </p:blipFill>
          <p:spPr>
            <a:xfrm>
              <a:off x="2366401" y="635826"/>
              <a:ext cx="1225418" cy="1225418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CA570F88-22D2-9140-9494-7195215D08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3500" t="12866" b="17439"/>
            <a:stretch/>
          </p:blipFill>
          <p:spPr>
            <a:xfrm>
              <a:off x="1067148" y="639262"/>
              <a:ext cx="1233578" cy="1164312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ACE4B7A-6E83-4B4B-9AC7-C568D6E10D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9000" t="23333" r="4500" b="1961"/>
            <a:stretch/>
          </p:blipFill>
          <p:spPr>
            <a:xfrm>
              <a:off x="3699022" y="646801"/>
              <a:ext cx="1225418" cy="1156585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3B37B02-AA30-F949-A17B-CAF2CB8EDE17}"/>
                </a:ext>
              </a:extLst>
            </p:cNvPr>
            <p:cNvSpPr txBox="1"/>
            <p:nvPr/>
          </p:nvSpPr>
          <p:spPr>
            <a:xfrm>
              <a:off x="4957724" y="1103480"/>
              <a:ext cx="400108" cy="27699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Calibri"/>
                  <a:cs typeface="Calibri"/>
                  <a:sym typeface="Calibri"/>
                </a:rPr>
                <a:t>PBS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10AB996-BE02-E241-BCDD-5DD424BBB4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4857" t="13671" r="12572" b="13558"/>
            <a:stretch/>
          </p:blipFill>
          <p:spPr>
            <a:xfrm>
              <a:off x="3686990" y="3191187"/>
              <a:ext cx="1273270" cy="1218825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B0820DE-4790-894B-B8B2-E162E0322C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8612" t="21856" r="3959" b="354"/>
            <a:stretch/>
          </p:blipFill>
          <p:spPr>
            <a:xfrm>
              <a:off x="2345716" y="3193604"/>
              <a:ext cx="1225417" cy="115627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20C7E0E6-BED9-5B45-B2C7-04A27947A9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612" t="22210" r="4959"/>
            <a:stretch/>
          </p:blipFill>
          <p:spPr>
            <a:xfrm>
              <a:off x="1067416" y="3193604"/>
              <a:ext cx="1198648" cy="1165537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88A7B1B-4268-3440-BD12-8090B861B343}"/>
                </a:ext>
              </a:extLst>
            </p:cNvPr>
            <p:cNvSpPr txBox="1"/>
            <p:nvPr/>
          </p:nvSpPr>
          <p:spPr>
            <a:xfrm>
              <a:off x="4941695" y="3567173"/>
              <a:ext cx="848948" cy="27699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Calibri"/>
                  <a:cs typeface="Calibri"/>
                  <a:sym typeface="Calibri"/>
                </a:rPr>
                <a:t>PBS + A</a:t>
              </a: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Symbol" pitchFamily="2" charset="2"/>
                  <a:sym typeface="Calibri"/>
                </a:rPr>
                <a:t>b</a:t>
              </a: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Calibri"/>
                  <a:cs typeface="Calibri"/>
                  <a:sym typeface="Calibri"/>
                </a:rPr>
                <a:t>o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F34B73E6-4681-2949-A5C4-A0D16DB67B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0644" t="13074" r="2454" b="14249"/>
            <a:stretch/>
          </p:blipFill>
          <p:spPr>
            <a:xfrm>
              <a:off x="3618741" y="4419518"/>
              <a:ext cx="1326565" cy="1218825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3A72BDA0-A6D2-3B48-8878-DCB6C23F83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t="13536" r="10383" b="1607"/>
            <a:stretch/>
          </p:blipFill>
          <p:spPr>
            <a:xfrm>
              <a:off x="1050222" y="4361885"/>
              <a:ext cx="1247551" cy="1270350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39929EB3-5AF0-AD42-9E80-827E569092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2715" t="15144" r="10383"/>
            <a:stretch/>
          </p:blipFill>
          <p:spPr>
            <a:xfrm>
              <a:off x="2340067" y="4391264"/>
              <a:ext cx="1225417" cy="1270350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F3805E6-0035-3B48-BE63-D8A2CAD1C610}"/>
                </a:ext>
              </a:extLst>
            </p:cNvPr>
            <p:cNvSpPr txBox="1"/>
            <p:nvPr/>
          </p:nvSpPr>
          <p:spPr>
            <a:xfrm>
              <a:off x="4941695" y="4812395"/>
              <a:ext cx="1163137" cy="27699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>
                  <a:latin typeface="+mn-lt"/>
                </a:rPr>
                <a:t>NSC-</a:t>
              </a:r>
              <a:r>
                <a:rPr lang="en-US" sz="1200" dirty="0" err="1">
                  <a:latin typeface="+mn-lt"/>
                </a:rPr>
                <a:t>exo</a:t>
              </a:r>
              <a:r>
                <a:rPr lang="en-US" sz="1200" dirty="0">
                  <a:latin typeface="+mn-lt"/>
                </a:rPr>
                <a:t> </a:t>
              </a: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Calibri"/>
                  <a:cs typeface="Calibri"/>
                  <a:sym typeface="Calibri"/>
                </a:rPr>
                <a:t>+ A</a:t>
              </a: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Symbol" pitchFamily="2" charset="2"/>
                  <a:sym typeface="Calibri"/>
                </a:rPr>
                <a:t>b</a:t>
              </a: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Calibri"/>
                  <a:cs typeface="Calibri"/>
                  <a:sym typeface="Calibri"/>
                </a:rPr>
                <a:t>o</a:t>
              </a:r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BD8FB7A5-C0B0-554D-A231-34ACE4FA54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81" t="12759" r="14919" b="14292"/>
            <a:stretch/>
          </p:blipFill>
          <p:spPr>
            <a:xfrm>
              <a:off x="1050222" y="5684479"/>
              <a:ext cx="1233039" cy="1205637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1B09B4EB-9286-CE46-98C3-2F6EFFDC94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43" t="13543" r="4317" b="14219"/>
            <a:stretch/>
          </p:blipFill>
          <p:spPr>
            <a:xfrm rot="10800000">
              <a:off x="2358189" y="5673716"/>
              <a:ext cx="1213956" cy="1232410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DAA00CF-34D1-4D4C-B9C8-5518050D18A2}"/>
                </a:ext>
              </a:extLst>
            </p:cNvPr>
            <p:cNvSpPr txBox="1"/>
            <p:nvPr/>
          </p:nvSpPr>
          <p:spPr>
            <a:xfrm>
              <a:off x="4957724" y="6102632"/>
              <a:ext cx="1078178" cy="27699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>
                  <a:latin typeface="+mn-lt"/>
                </a:rPr>
                <a:t>MN-</a:t>
              </a:r>
              <a:r>
                <a:rPr lang="en-US" sz="1200" dirty="0" err="1">
                  <a:latin typeface="+mn-lt"/>
                </a:rPr>
                <a:t>exo</a:t>
              </a:r>
              <a:r>
                <a:rPr lang="en-US" sz="1200" dirty="0">
                  <a:latin typeface="+mn-lt"/>
                </a:rPr>
                <a:t> </a:t>
              </a: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Calibri"/>
                  <a:cs typeface="Calibri"/>
                  <a:sym typeface="Calibri"/>
                </a:rPr>
                <a:t>+ A</a:t>
              </a: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Symbol" pitchFamily="2" charset="2"/>
                  <a:sym typeface="Calibri"/>
                </a:rPr>
                <a:t>b</a:t>
              </a:r>
              <a:r>
                <a:rPr kumimoji="0" lang="en-U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Calibri"/>
                  <a:cs typeface="Calibri"/>
                  <a:sym typeface="Calibri"/>
                </a:rPr>
                <a:t>o</a:t>
              </a:r>
            </a:p>
          </p:txBody>
        </p:sp>
        <p:pic>
          <p:nvPicPr>
            <p:cNvPr id="29" name="Picture 28" descr="A picture containing building&#10;&#10;Description automatically generated">
              <a:extLst>
                <a:ext uri="{FF2B5EF4-FFF2-40B4-BE49-F238E27FC236}">
                  <a16:creationId xmlns:a16="http://schemas.microsoft.com/office/drawing/2014/main" id="{ED7BAD33-1EEC-C744-93ED-1EBAE191BF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8" t="18350" r="8737" b="4329"/>
            <a:stretch/>
          </p:blipFill>
          <p:spPr>
            <a:xfrm rot="16200000">
              <a:off x="3613907" y="5640406"/>
              <a:ext cx="1261289" cy="1342339"/>
            </a:xfrm>
            <a:prstGeom prst="rect">
              <a:avLst/>
            </a:prstGeom>
          </p:spPr>
        </p:pic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D6685922-BCDE-E849-8F3B-2CDADAA185F9}"/>
              </a:ext>
            </a:extLst>
          </p:cNvPr>
          <p:cNvSpPr txBox="1"/>
          <p:nvPr/>
        </p:nvSpPr>
        <p:spPr>
          <a:xfrm>
            <a:off x="117030" y="228600"/>
            <a:ext cx="1634420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3105689416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05</TotalTime>
  <Words>23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icci, Maria A.</cp:lastModifiedBy>
  <cp:revision>176</cp:revision>
  <cp:lastPrinted>2019-04-15T16:22:02Z</cp:lastPrinted>
  <dcterms:modified xsi:type="dcterms:W3CDTF">2019-05-08T23:05:53Z</dcterms:modified>
</cp:coreProperties>
</file>